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DC15A4-5168-4179-A90A-98A6B0FA5416}" type="datetimeFigureOut">
              <a:rPr lang="en-GB" smtClean="0"/>
              <a:t>17/06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6BFEFB-581F-4291-AD8F-A7E34CA44B5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8289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0D937C9-B0AF-354D-A23F-46119D5B1787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34" charset="-128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626715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812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862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81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595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03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645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183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612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7681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60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9377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BB8AB5-F2E7-CE4E-ACEA-8E9BE1204F2C}" type="datetimeFigureOut">
              <a:rPr kumimoji="1" lang="ja-JP" altLang="en-US" smtClean="0"/>
              <a:t>2022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C623C-2088-ED40-8DBB-6BC461B8D8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2410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B856351-76C0-654D-A543-0A2E2532D6C5}"/>
              </a:ext>
            </a:extLst>
          </p:cNvPr>
          <p:cNvSpPr txBox="1"/>
          <p:nvPr/>
        </p:nvSpPr>
        <p:spPr>
          <a:xfrm>
            <a:off x="1598863" y="74863"/>
            <a:ext cx="2500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kumimoji="1" lang="en-US" altLang="ja-JP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Supplemental Figure 1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46FE667-8CC1-834F-81FB-2609FC32A2AD}"/>
              </a:ext>
            </a:extLst>
          </p:cNvPr>
          <p:cNvSpPr txBox="1"/>
          <p:nvPr/>
        </p:nvSpPr>
        <p:spPr>
          <a:xfrm>
            <a:off x="4394201" y="1735958"/>
            <a:ext cx="4255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NV</a:t>
            </a:r>
            <a:endParaRPr kumimoji="1" lang="ja-JP" altLang="en-US" sz="80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4E8320C-6D27-6542-83D1-C1E9E98DE30A}"/>
              </a:ext>
            </a:extLst>
          </p:cNvPr>
          <p:cNvSpPr txBox="1"/>
          <p:nvPr/>
        </p:nvSpPr>
        <p:spPr>
          <a:xfrm>
            <a:off x="4290926" y="2794091"/>
            <a:ext cx="526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200"/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V2W</a:t>
            </a:r>
            <a:endParaRPr kumimoji="1" lang="ja-JP" altLang="en-US" sz="80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953AFCB-2C19-7949-B724-2BA96F0F9276}"/>
              </a:ext>
            </a:extLst>
          </p:cNvPr>
          <p:cNvSpPr txBox="1"/>
          <p:nvPr/>
        </p:nvSpPr>
        <p:spPr>
          <a:xfrm>
            <a:off x="4817832" y="1138093"/>
            <a:ext cx="12593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WT</a:t>
            </a:r>
            <a:endParaRPr kumimoji="1" lang="ja-JP" altLang="en-US" sz="80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7F1A7C8-9CD5-1749-95BB-B62383555C84}"/>
              </a:ext>
            </a:extLst>
          </p:cNvPr>
          <p:cNvSpPr txBox="1"/>
          <p:nvPr/>
        </p:nvSpPr>
        <p:spPr>
          <a:xfrm>
            <a:off x="6111055" y="1138093"/>
            <a:ext cx="12593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1" lang="en-US" altLang="ja-JP" sz="800" i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jmj30 jmj32</a:t>
            </a:r>
            <a:endParaRPr kumimoji="1" lang="ja-JP" altLang="en-US" sz="800" i="1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2A87120-C85A-D145-9318-3F1A3C7948F8}"/>
              </a:ext>
            </a:extLst>
          </p:cNvPr>
          <p:cNvSpPr txBox="1"/>
          <p:nvPr/>
        </p:nvSpPr>
        <p:spPr>
          <a:xfrm>
            <a:off x="4817832" y="964904"/>
            <a:ext cx="25553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/>
            <a:r>
              <a:rPr kumimoji="1" lang="en-US" altLang="ja-JP" sz="800" i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FLC::GUS</a:t>
            </a:r>
            <a:endParaRPr kumimoji="1" lang="ja-JP" altLang="en-US" sz="800" i="1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4871C117-C466-914E-9CC4-1989B266845E}"/>
              </a:ext>
            </a:extLst>
          </p:cNvPr>
          <p:cNvCxnSpPr>
            <a:cxnSpLocks/>
          </p:cNvCxnSpPr>
          <p:nvPr/>
        </p:nvCxnSpPr>
        <p:spPr>
          <a:xfrm>
            <a:off x="4817834" y="1151996"/>
            <a:ext cx="255753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33CDCB7-F2D3-8840-A077-53C735802EA2}"/>
              </a:ext>
            </a:extLst>
          </p:cNvPr>
          <p:cNvSpPr txBox="1"/>
          <p:nvPr/>
        </p:nvSpPr>
        <p:spPr>
          <a:xfrm>
            <a:off x="2575292" y="5799664"/>
            <a:ext cx="70715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kumimoji="1" lang="en-US" altLang="ja-JP" sz="1200" b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Supplemental Figure 1 | 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GUS staining of seedlings of </a:t>
            </a:r>
            <a:r>
              <a:rPr kumimoji="1" lang="en-US" altLang="ja-JP" sz="1200" i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FLC::GUS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 and </a:t>
            </a:r>
            <a:r>
              <a:rPr kumimoji="1" lang="en-US" altLang="ja-JP" sz="1200" i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FLC::GUS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jmj30 jmj32 </a:t>
            </a:r>
            <a:r>
              <a:rPr kumimoji="1"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in various vernalized conditions. GUS signals were visualized in blue color.</a:t>
            </a:r>
            <a:endParaRPr kumimoji="1" lang="ja-JP" altLang="en-US" sz="120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pic>
        <p:nvPicPr>
          <p:cNvPr id="3" name="図 2" descr="持つ, 線画, ネックレス, プレート が含まれている画像&#10;&#10;自動的に生成された説明">
            <a:extLst>
              <a:ext uri="{FF2B5EF4-FFF2-40B4-BE49-F238E27FC236}">
                <a16:creationId xmlns:a16="http://schemas.microsoft.com/office/drawing/2014/main" id="{D78A40F8-F571-1546-8C5D-C789B00AF45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14834" y="1340082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2" name="図 11" descr="水, グリーン, ネックレス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EBD16FD2-EFE5-E74C-8845-0675047517C1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21611" y="1340082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4" name="図 23" descr="線画, 凧, 水 が含まれている画像&#10;&#10;自動的に生成された説明">
            <a:extLst>
              <a:ext uri="{FF2B5EF4-FFF2-40B4-BE49-F238E27FC236}">
                <a16:creationId xmlns:a16="http://schemas.microsoft.com/office/drawing/2014/main" id="{35184BD9-B3D7-B04D-9784-107EA0EFB360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14835" y="2392477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" name="図 25" descr="文字の書かれた紙&#10;&#10;中程度の精度で自動的に生成された説明">
            <a:extLst>
              <a:ext uri="{FF2B5EF4-FFF2-40B4-BE49-F238E27FC236}">
                <a16:creationId xmlns:a16="http://schemas.microsoft.com/office/drawing/2014/main" id="{023739D5-ADB6-F146-BB9E-2E362B26784A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21612" y="2392477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" name="図 27" descr="ホワイトボードに書かれた絵&#10;&#10;中程度の精度で自動的に生成された説明">
            <a:extLst>
              <a:ext uri="{FF2B5EF4-FFF2-40B4-BE49-F238E27FC236}">
                <a16:creationId xmlns:a16="http://schemas.microsoft.com/office/drawing/2014/main" id="{5C82DCB2-3C09-544A-9B12-ABD7E9C34D0B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14834" y="3444872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" name="図 29" descr="ホワイトボード が含まれている画像&#10;&#10;自動的に生成された説明">
            <a:extLst>
              <a:ext uri="{FF2B5EF4-FFF2-40B4-BE49-F238E27FC236}">
                <a16:creationId xmlns:a16="http://schemas.microsoft.com/office/drawing/2014/main" id="{51C1B0F2-E5E8-044E-9F73-4539503A9B99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21611" y="3444872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2" name="図 31" descr="ホワイトボードに書かれたイラスト&#10;&#10;低い精度で自動的に生成された説明">
            <a:extLst>
              <a:ext uri="{FF2B5EF4-FFF2-40B4-BE49-F238E27FC236}">
                <a16:creationId xmlns:a16="http://schemas.microsoft.com/office/drawing/2014/main" id="{E80BC236-3961-FE46-85E7-1D73CC37783F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11055" y="4497267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4" name="図 33" descr="文字の書かれた紙&#10;&#10;低い精度で自動的に生成された説明">
            <a:extLst>
              <a:ext uri="{FF2B5EF4-FFF2-40B4-BE49-F238E27FC236}">
                <a16:creationId xmlns:a16="http://schemas.microsoft.com/office/drawing/2014/main" id="{A9DDA2E3-1CE8-B743-8A78-C07BED989F19}"/>
              </a:ext>
            </a:extLst>
          </p:cNvPr>
          <p:cNvPicPr>
            <a:picLocks noChangeAspect="1"/>
          </p:cNvPicPr>
          <p:nvPr/>
        </p:nvPicPr>
        <p:blipFill>
          <a:blip r:embed="rId17" cstate="hq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17833" y="4497267"/>
            <a:ext cx="1259337" cy="100719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CCBAF75-EE1B-C14C-BCB2-0D5D9DCF5789}"/>
              </a:ext>
            </a:extLst>
          </p:cNvPr>
          <p:cNvSpPr txBox="1"/>
          <p:nvPr/>
        </p:nvSpPr>
        <p:spPr>
          <a:xfrm>
            <a:off x="4293251" y="3846486"/>
            <a:ext cx="526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200"/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V4W</a:t>
            </a:r>
            <a:endParaRPr kumimoji="1" lang="ja-JP" altLang="en-US" sz="80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2ED88F2-54F1-9D42-8906-17A8A9C67ABE}"/>
              </a:ext>
            </a:extLst>
          </p:cNvPr>
          <p:cNvSpPr txBox="1"/>
          <p:nvPr/>
        </p:nvSpPr>
        <p:spPr>
          <a:xfrm>
            <a:off x="4290926" y="4858117"/>
            <a:ext cx="526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457200"/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V6W</a:t>
            </a:r>
            <a:endParaRPr kumimoji="1" lang="ja-JP" altLang="en-US" sz="800">
              <a:solidFill>
                <a:prstClr val="black"/>
              </a:solidFill>
              <a:latin typeface="Times New Roman" panose="0202060305040502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5002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igail Rassette</dc:creator>
  <cp:lastModifiedBy>Abigail Rassette</cp:lastModifiedBy>
  <cp:revision>1</cp:revision>
  <dcterms:created xsi:type="dcterms:W3CDTF">2022-06-17T10:53:55Z</dcterms:created>
  <dcterms:modified xsi:type="dcterms:W3CDTF">2022-06-17T10:54:09Z</dcterms:modified>
</cp:coreProperties>
</file>